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3" r:id="rId2"/>
  </p:sldIdLst>
  <p:sldSz cx="684053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432FF"/>
    <a:srgbClr val="654B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3289"/>
    <p:restoredTop sz="94651"/>
  </p:normalViewPr>
  <p:slideViewPr>
    <p:cSldViewPr snapToGrid="0">
      <p:cViewPr varScale="1">
        <p:scale>
          <a:sx n="91" d="100"/>
          <a:sy n="91" d="100"/>
        </p:scale>
        <p:origin x="2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15E46-7790-044A-9762-68807AD201AC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143000"/>
            <a:ext cx="2441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A2C18D-D97C-FE4F-8227-06E7E77C1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64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ignificance between group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E3226-6799-F245-806D-B30FAF1174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5650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14125"/>
            <a:ext cx="5814457" cy="300826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538401"/>
            <a:ext cx="5130404" cy="2086184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8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7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60041"/>
            <a:ext cx="1474991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60041"/>
            <a:ext cx="4339466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6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154193"/>
            <a:ext cx="5899964" cy="3594317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782513"/>
            <a:ext cx="5899964" cy="189016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81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60043"/>
            <a:ext cx="5899964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18188"/>
            <a:ext cx="2893868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156278"/>
            <a:ext cx="2893868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18188"/>
            <a:ext cx="2908120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156278"/>
            <a:ext cx="2908120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4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7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44112"/>
            <a:ext cx="3463022" cy="6140542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44112"/>
            <a:ext cx="3463022" cy="6140542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60043"/>
            <a:ext cx="5899964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00203"/>
            <a:ext cx="5899964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008709"/>
            <a:ext cx="230868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extBox 95">
            <a:extLst>
              <a:ext uri="{FF2B5EF4-FFF2-40B4-BE49-F238E27FC236}">
                <a16:creationId xmlns:a16="http://schemas.microsoft.com/office/drawing/2014/main" id="{CA3C4B4B-2819-EAC3-712E-FD764548EF68}"/>
              </a:ext>
            </a:extLst>
          </p:cNvPr>
          <p:cNvSpPr txBox="1"/>
          <p:nvPr/>
        </p:nvSpPr>
        <p:spPr>
          <a:xfrm rot="16200000">
            <a:off x="33226" y="1098740"/>
            <a:ext cx="7585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26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Particles</a:t>
            </a:r>
            <a:r>
              <a:rPr lang="en-US" sz="626" b="1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BFFF72A-BB3A-BAFC-E8C5-BE2A1E06F420}"/>
              </a:ext>
            </a:extLst>
          </p:cNvPr>
          <p:cNvSpPr txBox="1"/>
          <p:nvPr/>
        </p:nvSpPr>
        <p:spPr>
          <a:xfrm>
            <a:off x="61383" y="562659"/>
            <a:ext cx="826935" cy="349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7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638F898-5D14-F3AA-CED1-2E88D6B4B444}"/>
              </a:ext>
            </a:extLst>
          </p:cNvPr>
          <p:cNvSpPr txBox="1"/>
          <p:nvPr/>
        </p:nvSpPr>
        <p:spPr>
          <a:xfrm>
            <a:off x="94426" y="1778662"/>
            <a:ext cx="826935" cy="349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7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2EC905C8-C63A-5569-596B-4C3BA93221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207" y="728870"/>
            <a:ext cx="1964261" cy="96170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378101B6-302D-0675-8E69-A6FEA678EC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5689" y="2074521"/>
            <a:ext cx="1997483" cy="957933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603EC3CD-6A4F-9F6E-B4E0-5D43870A39F1}"/>
              </a:ext>
            </a:extLst>
          </p:cNvPr>
          <p:cNvSpPr txBox="1"/>
          <p:nvPr/>
        </p:nvSpPr>
        <p:spPr>
          <a:xfrm>
            <a:off x="1032914" y="2967671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4EF75CD-BD70-20BF-FEA6-CFAA8E941486}"/>
              </a:ext>
            </a:extLst>
          </p:cNvPr>
          <p:cNvSpPr txBox="1"/>
          <p:nvPr/>
        </p:nvSpPr>
        <p:spPr>
          <a:xfrm rot="16200000">
            <a:off x="41880" y="2469370"/>
            <a:ext cx="8659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CD3/CD4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AF4C55F-CDBB-E991-734F-2A37E86266F1}"/>
              </a:ext>
            </a:extLst>
          </p:cNvPr>
          <p:cNvSpPr txBox="1"/>
          <p:nvPr/>
        </p:nvSpPr>
        <p:spPr>
          <a:xfrm>
            <a:off x="1567017" y="2143750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-0.05428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9244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31D00150-2274-4BAE-071A-E2159C6578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78153" y="2070302"/>
            <a:ext cx="2011403" cy="96668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598A1315-B50B-1D2B-E5E5-9A20B5AA7987}"/>
              </a:ext>
            </a:extLst>
          </p:cNvPr>
          <p:cNvSpPr txBox="1"/>
          <p:nvPr/>
        </p:nvSpPr>
        <p:spPr>
          <a:xfrm>
            <a:off x="3147977" y="2967671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B5B3336-287D-D93C-19B2-D430ECBA509E}"/>
              </a:ext>
            </a:extLst>
          </p:cNvPr>
          <p:cNvSpPr txBox="1"/>
          <p:nvPr/>
        </p:nvSpPr>
        <p:spPr>
          <a:xfrm>
            <a:off x="3741568" y="2252384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-0.01107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960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C5F10B9-F766-98B3-BC43-123147A8A062}"/>
              </a:ext>
            </a:extLst>
          </p:cNvPr>
          <p:cNvSpPr txBox="1"/>
          <p:nvPr/>
        </p:nvSpPr>
        <p:spPr>
          <a:xfrm rot="16200000">
            <a:off x="2050570" y="2495448"/>
            <a:ext cx="8659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CD4/CD45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28D17023-9F40-8BE2-E4B1-A9B45AA2C8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6524" y="3507623"/>
            <a:ext cx="1997483" cy="957933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386BD402-9E8C-E6B5-4C80-68F264A0AC1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51266" y="2074083"/>
            <a:ext cx="1994997" cy="958805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EA0C6F18-27C8-0442-A035-657D7C43B89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99279" y="3512161"/>
            <a:ext cx="1995404" cy="961226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023F1A31-4B29-2677-B234-5EC374589CE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56386" y="3498342"/>
            <a:ext cx="1984289" cy="957933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D678C567-83C0-75FC-ABBA-927827B1FC6F}"/>
              </a:ext>
            </a:extLst>
          </p:cNvPr>
          <p:cNvSpPr txBox="1"/>
          <p:nvPr/>
        </p:nvSpPr>
        <p:spPr>
          <a:xfrm>
            <a:off x="5065752" y="4412293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2FF2025-926C-4AEB-2DDB-1D7639FB0706}"/>
              </a:ext>
            </a:extLst>
          </p:cNvPr>
          <p:cNvSpPr txBox="1"/>
          <p:nvPr/>
        </p:nvSpPr>
        <p:spPr>
          <a:xfrm>
            <a:off x="5689705" y="3647557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-0.04210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976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94AF5FD-0656-1B01-221C-A87AC8877976}"/>
              </a:ext>
            </a:extLst>
          </p:cNvPr>
          <p:cNvSpPr txBox="1"/>
          <p:nvPr/>
        </p:nvSpPr>
        <p:spPr>
          <a:xfrm rot="16200000">
            <a:off x="4013181" y="3904193"/>
            <a:ext cx="8659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CD45/CD9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E9B53DA-7A2C-4AB4-B953-A614C2E6D03E}"/>
              </a:ext>
            </a:extLst>
          </p:cNvPr>
          <p:cNvSpPr txBox="1"/>
          <p:nvPr/>
        </p:nvSpPr>
        <p:spPr>
          <a:xfrm>
            <a:off x="3544443" y="3721669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0.1102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584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2461119-3251-02D4-568D-86B204C94E97}"/>
              </a:ext>
            </a:extLst>
          </p:cNvPr>
          <p:cNvSpPr txBox="1"/>
          <p:nvPr/>
        </p:nvSpPr>
        <p:spPr>
          <a:xfrm>
            <a:off x="3022497" y="4412293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8392C07-95D5-8874-4652-588DD3485BC2}"/>
              </a:ext>
            </a:extLst>
          </p:cNvPr>
          <p:cNvSpPr txBox="1"/>
          <p:nvPr/>
        </p:nvSpPr>
        <p:spPr>
          <a:xfrm rot="16200000">
            <a:off x="1972432" y="3889418"/>
            <a:ext cx="9156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CD19/CD4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3AAC86F-48DE-4A0D-4BB0-5BA78A729428}"/>
              </a:ext>
            </a:extLst>
          </p:cNvPr>
          <p:cNvSpPr txBox="1"/>
          <p:nvPr/>
        </p:nvSpPr>
        <p:spPr>
          <a:xfrm>
            <a:off x="5017276" y="2986491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A36D5A5-484B-7705-548F-906215D48777}"/>
              </a:ext>
            </a:extLst>
          </p:cNvPr>
          <p:cNvSpPr txBox="1"/>
          <p:nvPr/>
        </p:nvSpPr>
        <p:spPr>
          <a:xfrm>
            <a:off x="5672160" y="2215055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0.2106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690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07FA348-F799-FDDA-9EAF-402D7177B9ED}"/>
              </a:ext>
            </a:extLst>
          </p:cNvPr>
          <p:cNvSpPr txBox="1"/>
          <p:nvPr/>
        </p:nvSpPr>
        <p:spPr>
          <a:xfrm rot="16200000">
            <a:off x="4063858" y="2492620"/>
            <a:ext cx="86594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CD8/CD4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4909C6F-96FB-F7F9-A383-F758409D7B28}"/>
              </a:ext>
            </a:extLst>
          </p:cNvPr>
          <p:cNvSpPr txBox="1"/>
          <p:nvPr/>
        </p:nvSpPr>
        <p:spPr>
          <a:xfrm>
            <a:off x="1042525" y="4412293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07A8F03-E00F-CCE2-DFC3-9FF9F4B2A175}"/>
              </a:ext>
            </a:extLst>
          </p:cNvPr>
          <p:cNvSpPr txBox="1"/>
          <p:nvPr/>
        </p:nvSpPr>
        <p:spPr>
          <a:xfrm rot="16200000">
            <a:off x="21348" y="3887622"/>
            <a:ext cx="9156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CD14/CD4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572B820-05AF-66DB-D801-795778CA10B1}"/>
              </a:ext>
            </a:extLst>
          </p:cNvPr>
          <p:cNvSpPr txBox="1"/>
          <p:nvPr/>
        </p:nvSpPr>
        <p:spPr>
          <a:xfrm>
            <a:off x="1628525" y="3515866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0.1151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592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D937834-43D6-954C-ED1C-A80164B5303B}"/>
              </a:ext>
            </a:extLst>
          </p:cNvPr>
          <p:cNvSpPr txBox="1"/>
          <p:nvPr/>
        </p:nvSpPr>
        <p:spPr>
          <a:xfrm>
            <a:off x="1473249" y="747682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-0.01646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939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EB6C06-3BA0-330D-A975-7291BE01EFA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22016" y="726647"/>
            <a:ext cx="1964261" cy="96170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7510F5D-DE0B-16BE-F1D4-5322DA615A4C}"/>
              </a:ext>
            </a:extLst>
          </p:cNvPr>
          <p:cNvSpPr txBox="1"/>
          <p:nvPr/>
        </p:nvSpPr>
        <p:spPr>
          <a:xfrm rot="16200000">
            <a:off x="1935600" y="1032805"/>
            <a:ext cx="829073" cy="198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89" b="1" dirty="0">
                <a:latin typeface="Arial" panose="020B0604020202020204" pitchFamily="34" charset="0"/>
                <a:cs typeface="Arial" panose="020B0604020202020204" pitchFamily="34" charset="0"/>
              </a:rPr>
              <a:t>Mean Size (nm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6A46AB-475A-4FD4-2A4F-70CB002D130E}"/>
              </a:ext>
            </a:extLst>
          </p:cNvPr>
          <p:cNvSpPr txBox="1"/>
          <p:nvPr/>
        </p:nvSpPr>
        <p:spPr>
          <a:xfrm>
            <a:off x="1046157" y="1633336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18D24B8-09C4-C0D1-2E23-E24967BB60AB}"/>
              </a:ext>
            </a:extLst>
          </p:cNvPr>
          <p:cNvSpPr txBox="1"/>
          <p:nvPr/>
        </p:nvSpPr>
        <p:spPr>
          <a:xfrm>
            <a:off x="2926697" y="1622678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pNf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Z-scor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3BB0E82-D202-BF87-0839-C2CD2652DD30}"/>
              </a:ext>
            </a:extLst>
          </p:cNvPr>
          <p:cNvSpPr txBox="1"/>
          <p:nvPr/>
        </p:nvSpPr>
        <p:spPr>
          <a:xfrm>
            <a:off x="3437554" y="767675"/>
            <a:ext cx="1150833" cy="2979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r=-0.2034</a:t>
            </a:r>
          </a:p>
          <a:p>
            <a:r>
              <a:rPr lang="en-CA" sz="668" i="1" dirty="0">
                <a:solidFill>
                  <a:srgbClr val="000000"/>
                </a:solidFill>
                <a:latin typeface="Arial" panose="020B0604020202020204" pitchFamily="34" charset="0"/>
              </a:rPr>
              <a:t>p</a:t>
            </a:r>
            <a:r>
              <a:rPr lang="en-CA" sz="668" dirty="0">
                <a:solidFill>
                  <a:srgbClr val="000000"/>
                </a:solidFill>
                <a:latin typeface="Arial" panose="020B0604020202020204" pitchFamily="34" charset="0"/>
              </a:rPr>
              <a:t>=0.340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7D9AB43-7512-81D1-38D5-4A0CC201A0F5}"/>
              </a:ext>
            </a:extLst>
          </p:cNvPr>
          <p:cNvSpPr txBox="1"/>
          <p:nvPr/>
        </p:nvSpPr>
        <p:spPr>
          <a:xfrm>
            <a:off x="175909" y="133780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FD382D2-5393-6825-79E3-436638C1CD7A}"/>
              </a:ext>
            </a:extLst>
          </p:cNvPr>
          <p:cNvSpPr txBox="1"/>
          <p:nvPr/>
        </p:nvSpPr>
        <p:spPr>
          <a:xfrm>
            <a:off x="1041585" y="3305741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EV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0229F63-494B-238E-8491-5B6B7EF9F1AC}"/>
              </a:ext>
            </a:extLst>
          </p:cNvPr>
          <p:cNvSpPr txBox="1"/>
          <p:nvPr/>
        </p:nvSpPr>
        <p:spPr>
          <a:xfrm>
            <a:off x="3017802" y="3311069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EV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AED3EA7-1A76-E541-5656-9561215EBB11}"/>
              </a:ext>
            </a:extLst>
          </p:cNvPr>
          <p:cNvSpPr txBox="1"/>
          <p:nvPr/>
        </p:nvSpPr>
        <p:spPr>
          <a:xfrm>
            <a:off x="5070670" y="3291030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EV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8DF35B1-359A-7D1E-0B4D-00140242EE68}"/>
              </a:ext>
            </a:extLst>
          </p:cNvPr>
          <p:cNvSpPr txBox="1"/>
          <p:nvPr/>
        </p:nvSpPr>
        <p:spPr>
          <a:xfrm>
            <a:off x="1063364" y="1881767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 EV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CC7AEA-045C-688E-1AAF-3371E90590F3}"/>
              </a:ext>
            </a:extLst>
          </p:cNvPr>
          <p:cNvSpPr txBox="1"/>
          <p:nvPr/>
        </p:nvSpPr>
        <p:spPr>
          <a:xfrm>
            <a:off x="3241183" y="1867871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 EV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95A8E7-CC57-2F59-737D-399B53CC8C23}"/>
              </a:ext>
            </a:extLst>
          </p:cNvPr>
          <p:cNvSpPr txBox="1"/>
          <p:nvPr/>
        </p:nvSpPr>
        <p:spPr>
          <a:xfrm>
            <a:off x="5084979" y="1867871"/>
            <a:ext cx="7168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EVs</a:t>
            </a:r>
          </a:p>
        </p:txBody>
      </p:sp>
    </p:spTree>
    <p:extLst>
      <p:ext uri="{BB962C8B-B14F-4D97-AF65-F5344CB8AC3E}">
        <p14:creationId xmlns:p14="http://schemas.microsoft.com/office/powerpoint/2010/main" val="2894787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</TotalTime>
  <Words>119</Words>
  <Application>Microsoft Macintosh PowerPoint</Application>
  <PresentationFormat>Custom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Leigh Zagrodnik</dc:creator>
  <cp:lastModifiedBy>Moore, Craig S.</cp:lastModifiedBy>
  <cp:revision>28</cp:revision>
  <cp:lastPrinted>2024-10-15T17:54:31Z</cp:lastPrinted>
  <dcterms:created xsi:type="dcterms:W3CDTF">2024-10-10T14:11:55Z</dcterms:created>
  <dcterms:modified xsi:type="dcterms:W3CDTF">2024-12-20T19:18:12Z</dcterms:modified>
</cp:coreProperties>
</file>